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  <p:sldId id="272" r:id="rId3"/>
    <p:sldId id="260" r:id="rId4"/>
    <p:sldId id="280" r:id="rId5"/>
    <p:sldId id="278" r:id="rId6"/>
    <p:sldId id="279" r:id="rId7"/>
    <p:sldId id="273" r:id="rId8"/>
    <p:sldId id="277" r:id="rId9"/>
    <p:sldId id="274" r:id="rId10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9" autoAdjust="0"/>
    <p:restoredTop sz="94660"/>
  </p:normalViewPr>
  <p:slideViewPr>
    <p:cSldViewPr snapToGrid="0">
      <p:cViewPr varScale="1">
        <p:scale>
          <a:sx n="88" d="100"/>
          <a:sy n="88" d="100"/>
        </p:scale>
        <p:origin x="40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eranlab\Desktop\Nasren%202022\sCD72\CBA\CBA-sCD7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eranlab\Desktop\Nasren%202022\sCD72\CBA\CBA-sCD7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IL-17A pg/mL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IL-17A'!$A$2:$A$3</c:f>
              <c:strCache>
                <c:ptCount val="2"/>
                <c:pt idx="0">
                  <c:v>Control</c:v>
                </c:pt>
                <c:pt idx="1">
                  <c:v>  sCD72</c:v>
                </c:pt>
              </c:strCache>
            </c:strRef>
          </c:cat>
          <c:val>
            <c:numRef>
              <c:f>'IL-17A'!$F$2:$F$3</c:f>
              <c:numCache>
                <c:formatCode>0.00</c:formatCode>
                <c:ptCount val="2"/>
                <c:pt idx="0">
                  <c:v>200.30692549830391</c:v>
                </c:pt>
                <c:pt idx="1">
                  <c:v>1782.08091790184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2A-4BC6-8207-D3661AED20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427712"/>
        <c:axId val="61429248"/>
      </c:barChart>
      <c:catAx>
        <c:axId val="614277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1429248"/>
        <c:crosses val="autoZero"/>
        <c:auto val="1"/>
        <c:lblAlgn val="ctr"/>
        <c:lblOffset val="100"/>
        <c:noMultiLvlLbl val="0"/>
      </c:catAx>
      <c:valAx>
        <c:axId val="61429248"/>
        <c:scaling>
          <c:orientation val="minMax"/>
        </c:scaling>
        <c:delete val="0"/>
        <c:axPos val="l"/>
        <c:majorGridlines/>
        <c:numFmt formatCode="0.00" sourceLinked="1"/>
        <c:majorTickMark val="out"/>
        <c:minorTickMark val="none"/>
        <c:tickLblPos val="nextTo"/>
        <c:crossAx val="614277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IFN-</a:t>
            </a:r>
            <a:r>
              <a:rPr lang="el-GR"/>
              <a:t>γ</a:t>
            </a:r>
            <a:r>
              <a:rPr lang="en-US"/>
              <a:t> </a:t>
            </a:r>
            <a:r>
              <a:rPr lang="en-US" sz="1800" b="1" i="0" baseline="0">
                <a:effectLst/>
              </a:rPr>
              <a:t>pg/mL</a:t>
            </a:r>
            <a:endParaRPr lang="he-IL">
              <a:effectLst/>
            </a:endParaRP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IFN-γ '!$A$2:$A$3</c:f>
              <c:strCache>
                <c:ptCount val="2"/>
                <c:pt idx="0">
                  <c:v>Control </c:v>
                </c:pt>
                <c:pt idx="1">
                  <c:v>sCD72</c:v>
                </c:pt>
              </c:strCache>
            </c:strRef>
          </c:cat>
          <c:val>
            <c:numRef>
              <c:f>'IFN-γ '!$F$2:$F$3</c:f>
              <c:numCache>
                <c:formatCode>0.00</c:formatCode>
                <c:ptCount val="2"/>
                <c:pt idx="0">
                  <c:v>1450.311867734287</c:v>
                </c:pt>
                <c:pt idx="1">
                  <c:v>3700.73691534155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38-480D-9BDF-B7E6CE124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3514880"/>
        <c:axId val="63520768"/>
      </c:barChart>
      <c:catAx>
        <c:axId val="63514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3520768"/>
        <c:crosses val="autoZero"/>
        <c:auto val="1"/>
        <c:lblAlgn val="ctr"/>
        <c:lblOffset val="100"/>
        <c:noMultiLvlLbl val="0"/>
      </c:catAx>
      <c:valAx>
        <c:axId val="63520768"/>
        <c:scaling>
          <c:orientation val="minMax"/>
        </c:scaling>
        <c:delete val="0"/>
        <c:axPos val="l"/>
        <c:majorGridlines/>
        <c:numFmt formatCode="0.00" sourceLinked="1"/>
        <c:majorTickMark val="out"/>
        <c:minorTickMark val="none"/>
        <c:tickLblPos val="nextTo"/>
        <c:crossAx val="63514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4" Type="http://schemas.openxmlformats.org/officeDocument/2006/relationships/image" Target="../media/image1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12073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40136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94075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45295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73101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41978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55331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54927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19311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7562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24812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8F6481-C68D-42AC-946C-1C17824DF893}" type="datetimeFigureOut">
              <a:rPr lang="he-IL" smtClean="0"/>
              <a:t>ה'/אייר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5EC20-B0E7-4CB7-A609-A6CF583C7B9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40688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1.emf"/><Relationship Id="rId4" Type="http://schemas.openxmlformats.org/officeDocument/2006/relationships/image" Target="../media/image8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957261" y="677367"/>
            <a:ext cx="32412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/>
              <a:t>A</a:t>
            </a:r>
            <a:endParaRPr lang="he-IL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991028" y="2942356"/>
            <a:ext cx="31771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/>
              <a:t>C</a:t>
            </a:r>
            <a:endParaRPr lang="he-IL" b="1" dirty="0"/>
          </a:p>
        </p:txBody>
      </p:sp>
      <p:grpSp>
        <p:nvGrpSpPr>
          <p:cNvPr id="27" name="Group 26"/>
          <p:cNvGrpSpPr/>
          <p:nvPr/>
        </p:nvGrpSpPr>
        <p:grpSpPr>
          <a:xfrm>
            <a:off x="1281389" y="657515"/>
            <a:ext cx="2702633" cy="2044661"/>
            <a:chOff x="140753" y="786275"/>
            <a:chExt cx="2702633" cy="2044661"/>
          </a:xfrm>
        </p:grpSpPr>
        <p:sp>
          <p:nvSpPr>
            <p:cNvPr id="28" name="Rectangle 68"/>
            <p:cNvSpPr>
              <a:spLocks noChangeArrowheads="1"/>
            </p:cNvSpPr>
            <p:nvPr/>
          </p:nvSpPr>
          <p:spPr bwMode="auto">
            <a:xfrm>
              <a:off x="381076" y="1302656"/>
              <a:ext cx="1950322" cy="195152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l" rtl="0"/>
              <a:r>
                <a:rPr lang="en-US" sz="900" b="1" dirty="0">
                  <a:latin typeface="Verdana" panose="020B0604030504040204" pitchFamily="34" charset="0"/>
                  <a:ea typeface="Verdana" panose="020B0604030504040204" pitchFamily="34" charset="0"/>
                  <a:cs typeface="Times New Roman" pitchFamily="18" charset="0"/>
                </a:rPr>
                <a:t>Full length CD72</a:t>
              </a:r>
            </a:p>
          </p:txBody>
        </p:sp>
        <p:sp>
          <p:nvSpPr>
            <p:cNvPr id="29" name="Text Box 74"/>
            <p:cNvSpPr txBox="1">
              <a:spLocks noChangeArrowheads="1"/>
            </p:cNvSpPr>
            <p:nvPr/>
          </p:nvSpPr>
          <p:spPr bwMode="auto">
            <a:xfrm>
              <a:off x="372256" y="1631054"/>
              <a:ext cx="224207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l" rtl="0"/>
              <a:r>
                <a:rPr lang="en-US" sz="900" dirty="0">
                  <a:latin typeface="Times New Roman" pitchFamily="18" charset="0"/>
                  <a:cs typeface="Times New Roman" pitchFamily="18" charset="0"/>
                </a:rPr>
                <a:t>                                      </a:t>
              </a:r>
            </a:p>
          </p:txBody>
        </p:sp>
        <p:sp>
          <p:nvSpPr>
            <p:cNvPr id="30" name="Rectangle 63"/>
            <p:cNvSpPr>
              <a:spLocks noChangeArrowheads="1"/>
            </p:cNvSpPr>
            <p:nvPr/>
          </p:nvSpPr>
          <p:spPr bwMode="auto">
            <a:xfrm>
              <a:off x="386686" y="1883146"/>
              <a:ext cx="1263005" cy="193646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l" rtl="0"/>
              <a:r>
                <a:rPr lang="en-US" sz="900" b="1" dirty="0">
                  <a:latin typeface="Verdana" panose="020B0604030504040204" pitchFamily="34" charset="0"/>
                  <a:ea typeface="Verdana" panose="020B0604030504040204" pitchFamily="34" charset="0"/>
                  <a:cs typeface="Times New Roman" pitchFamily="18" charset="0"/>
                </a:rPr>
                <a:t>sCD72</a:t>
              </a:r>
            </a:p>
          </p:txBody>
        </p:sp>
        <p:sp>
          <p:nvSpPr>
            <p:cNvPr id="31" name="Rectangle 30"/>
            <p:cNvSpPr/>
            <p:nvPr/>
          </p:nvSpPr>
          <p:spPr bwMode="auto">
            <a:xfrm>
              <a:off x="140753" y="786275"/>
              <a:ext cx="2702633" cy="2044661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he-IL" sz="900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1654231" y="1883146"/>
              <a:ext cx="238082" cy="19515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AutoShape 65"/>
            <p:cNvSpPr>
              <a:spLocks noChangeArrowheads="1"/>
            </p:cNvSpPr>
            <p:nvPr/>
          </p:nvSpPr>
          <p:spPr bwMode="auto">
            <a:xfrm>
              <a:off x="1716597" y="2091005"/>
              <a:ext cx="74602" cy="153664"/>
            </a:xfrm>
            <a:prstGeom prst="upArrow">
              <a:avLst>
                <a:gd name="adj1" fmla="val 50000"/>
                <a:gd name="adj2" fmla="val 54018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endParaRPr lang="he-IL" sz="9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596348" y="2198774"/>
              <a:ext cx="4331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His</a:t>
              </a:r>
            </a:p>
          </p:txBody>
        </p:sp>
        <p:sp>
          <p:nvSpPr>
            <p:cNvPr id="35" name="AutoShape 65"/>
            <p:cNvSpPr>
              <a:spLocks noChangeArrowheads="1"/>
            </p:cNvSpPr>
            <p:nvPr/>
          </p:nvSpPr>
          <p:spPr bwMode="auto">
            <a:xfrm rot="10800000">
              <a:off x="1612904" y="1713936"/>
              <a:ext cx="74602" cy="153664"/>
            </a:xfrm>
            <a:prstGeom prst="upArrow">
              <a:avLst>
                <a:gd name="adj1" fmla="val 50000"/>
                <a:gd name="adj2" fmla="val 54018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endParaRPr lang="he-IL" sz="9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AutoShape 65"/>
            <p:cNvSpPr>
              <a:spLocks noChangeArrowheads="1"/>
            </p:cNvSpPr>
            <p:nvPr/>
          </p:nvSpPr>
          <p:spPr bwMode="auto">
            <a:xfrm rot="10800000">
              <a:off x="2274371" y="1105042"/>
              <a:ext cx="74602" cy="153664"/>
            </a:xfrm>
            <a:prstGeom prst="upArrow">
              <a:avLst>
                <a:gd name="adj1" fmla="val 50000"/>
                <a:gd name="adj2" fmla="val 54018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endParaRPr lang="he-IL" sz="9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471118" y="1518895"/>
              <a:ext cx="3770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9</a:t>
              </a: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1898070" y="1883146"/>
              <a:ext cx="238082" cy="19515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AutoShape 65"/>
            <p:cNvSpPr>
              <a:spLocks noChangeArrowheads="1"/>
            </p:cNvSpPr>
            <p:nvPr/>
          </p:nvSpPr>
          <p:spPr bwMode="auto">
            <a:xfrm rot="10800000">
              <a:off x="1396516" y="1105042"/>
              <a:ext cx="74602" cy="153664"/>
            </a:xfrm>
            <a:prstGeom prst="upArrow">
              <a:avLst>
                <a:gd name="adj1" fmla="val 50000"/>
                <a:gd name="adj2" fmla="val 54018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endParaRPr lang="he-IL" sz="9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261929" y="915067"/>
              <a:ext cx="3770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7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152147" y="915067"/>
              <a:ext cx="3770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9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898266" y="2210413"/>
              <a:ext cx="4331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5</a:t>
              </a:r>
            </a:p>
          </p:txBody>
        </p:sp>
        <p:sp>
          <p:nvSpPr>
            <p:cNvPr id="45" name="AutoShape 65"/>
            <p:cNvSpPr>
              <a:spLocks noChangeArrowheads="1"/>
            </p:cNvSpPr>
            <p:nvPr/>
          </p:nvSpPr>
          <p:spPr bwMode="auto">
            <a:xfrm>
              <a:off x="2001999" y="2091005"/>
              <a:ext cx="74602" cy="153664"/>
            </a:xfrm>
            <a:prstGeom prst="upArrow">
              <a:avLst>
                <a:gd name="adj1" fmla="val 50000"/>
                <a:gd name="adj2" fmla="val 54018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endParaRPr lang="he-IL" sz="90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293297" y="103517"/>
            <a:ext cx="769763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S1</a:t>
            </a:r>
            <a:endParaRPr lang="he-IL" dirty="0"/>
          </a:p>
        </p:txBody>
      </p:sp>
      <p:sp>
        <p:nvSpPr>
          <p:cNvPr id="47" name="TextBox 46"/>
          <p:cNvSpPr txBox="1"/>
          <p:nvPr/>
        </p:nvSpPr>
        <p:spPr>
          <a:xfrm>
            <a:off x="5639639" y="472849"/>
            <a:ext cx="330591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/>
              <a:t>B</a:t>
            </a:r>
            <a:endParaRPr lang="he-IL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EDBE6B-A748-5D4F-F94E-00BFC7750E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5460" y="3033349"/>
            <a:ext cx="3664449" cy="17449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1279" y="579329"/>
            <a:ext cx="4180523" cy="332045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81389" y="5059680"/>
            <a:ext cx="10614520" cy="175432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/>
              <a:t>(A)</a:t>
            </a:r>
            <a:r>
              <a:rPr lang="en-US" dirty="0"/>
              <a:t> The sCD72 sequence contains the extracellular region of CD72 (amino acids 117-359 of the full-length CD72). </a:t>
            </a:r>
          </a:p>
          <a:p>
            <a:r>
              <a:rPr lang="en-US" b="1" dirty="0"/>
              <a:t>(B)</a:t>
            </a:r>
            <a:r>
              <a:rPr lang="en-US" dirty="0"/>
              <a:t> The map of the sCD72 construct cloned into NSPI plasmid with 8xHIS and V5 epitope tags</a:t>
            </a:r>
            <a:r>
              <a:rPr lang="he-IL" dirty="0"/>
              <a:t>.  </a:t>
            </a:r>
            <a:endParaRPr lang="en-US" dirty="0"/>
          </a:p>
          <a:p>
            <a:r>
              <a:rPr lang="en-US" b="1" dirty="0"/>
              <a:t>(C)</a:t>
            </a:r>
            <a:r>
              <a:rPr lang="en-US" dirty="0"/>
              <a:t> Conditioned media of HEK-293T-sCD72 cells were collected at different time points (12, 24, and 72 hours) and analyzed by western blot using an antibody directed against the V5-tag of sCD72. </a:t>
            </a:r>
          </a:p>
          <a:p>
            <a:r>
              <a:rPr lang="en-US" dirty="0"/>
              <a:t>sCD72=soluble CD72; h=hours; CM= Conditioned media; P=Purified protein.</a:t>
            </a:r>
          </a:p>
          <a:p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6718178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3359" y="238603"/>
            <a:ext cx="2673681" cy="64633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2A:</a:t>
            </a:r>
            <a:endParaRPr lang="en-US" dirty="0"/>
          </a:p>
          <a:p>
            <a:r>
              <a:rPr lang="en-US" dirty="0"/>
              <a:t>CD100 and CD72/V5 CO-I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F8E6015-5E2A-029F-19B8-9F1AD9153F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0200" y="900238"/>
            <a:ext cx="7772400" cy="426504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F5247A5-B1FE-4950-D729-3041F17C60C1}"/>
              </a:ext>
            </a:extLst>
          </p:cNvPr>
          <p:cNvSpPr txBox="1"/>
          <p:nvPr/>
        </p:nvSpPr>
        <p:spPr>
          <a:xfrm>
            <a:off x="486102" y="5165281"/>
            <a:ext cx="10464800" cy="14541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 cells were stimulated with sCD72-V5 in the presence of different concentrations of BS3 cross-linker (0, 1, 2.5,5 mM) or with a control (C). Cell lysates were then prepared and immunoprecipitated using V5-tag </a:t>
            </a:r>
            <a:r>
              <a:rPr lang="en-US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mAb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magnetic beads. Blots prepared from the </a:t>
            </a:r>
            <a:r>
              <a:rPr lang="en-US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immunoprecipitates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were probed with anti-CD100 followed by anti-V5 antibodies. </a:t>
            </a:r>
          </a:p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Lys=cell lysate. E=Elution fraction. </a:t>
            </a:r>
            <a:endParaRPr lang="en-US" sz="1400" dirty="0">
              <a:solidFill>
                <a:srgbClr val="000000"/>
              </a:solidFill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5907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4809724" y="2491428"/>
            <a:ext cx="117320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Anti CD47 </a:t>
            </a:r>
            <a:endParaRPr lang="he-IL" dirty="0"/>
          </a:p>
        </p:txBody>
      </p:sp>
      <p:sp>
        <p:nvSpPr>
          <p:cNvPr id="4" name="TextBox 3"/>
          <p:cNvSpPr txBox="1"/>
          <p:nvPr/>
        </p:nvSpPr>
        <p:spPr>
          <a:xfrm>
            <a:off x="893331" y="310550"/>
            <a:ext cx="2556662" cy="923330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2B:</a:t>
            </a:r>
            <a:endParaRPr lang="en-US" dirty="0"/>
          </a:p>
          <a:p>
            <a:r>
              <a:rPr lang="en-US" dirty="0"/>
              <a:t>CD47 and CD72/V5 CO-IP</a:t>
            </a:r>
          </a:p>
          <a:p>
            <a:pPr marL="342900" indent="-342900">
              <a:buAutoNum type="arabicPeriod"/>
            </a:pP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261" y="1886075"/>
            <a:ext cx="4077487" cy="16587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A8BAF16-65C3-A866-F597-9B735F0AD9E1}"/>
              </a:ext>
            </a:extLst>
          </p:cNvPr>
          <p:cNvSpPr txBox="1"/>
          <p:nvPr/>
        </p:nvSpPr>
        <p:spPr>
          <a:xfrm>
            <a:off x="584166" y="4366572"/>
            <a:ext cx="10464800" cy="10283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 cells were stimulated with concentrated conditioned media of sCD72-V5 (sCD72) or control media (c). Cell lysates were then prepared and immunoprecipitated using V5-tag </a:t>
            </a:r>
            <a:r>
              <a:rPr lang="en-US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mAb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magnetic beads. Blot prepared from the </a:t>
            </a:r>
            <a:r>
              <a:rPr lang="en-US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immunoprecipitates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was probed with anti-CD47 antibody. The gel shows the results of two </a:t>
            </a:r>
            <a:r>
              <a:rPr lang="en-US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elutions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(E1+E2) of the same experiment. </a:t>
            </a:r>
            <a:endParaRPr lang="en-US" sz="14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7E046EF-691B-78CE-09D6-F8439066A51A}"/>
              </a:ext>
            </a:extLst>
          </p:cNvPr>
          <p:cNvSpPr/>
          <p:nvPr/>
        </p:nvSpPr>
        <p:spPr>
          <a:xfrm>
            <a:off x="2313383" y="1972853"/>
            <a:ext cx="831627" cy="3693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CD72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4E0D7B1-44A4-2EAE-FE7E-ECF5FD37148D}"/>
              </a:ext>
            </a:extLst>
          </p:cNvPr>
          <p:cNvSpPr/>
          <p:nvPr/>
        </p:nvSpPr>
        <p:spPr>
          <a:xfrm>
            <a:off x="2007366" y="1972854"/>
            <a:ext cx="524930" cy="3693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 C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B3DEBF4-8E15-21FC-CB05-FB3A3D76656D}"/>
              </a:ext>
            </a:extLst>
          </p:cNvPr>
          <p:cNvSpPr/>
          <p:nvPr/>
        </p:nvSpPr>
        <p:spPr>
          <a:xfrm>
            <a:off x="3330997" y="1972853"/>
            <a:ext cx="831627" cy="3693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CD72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55062E5-9E1A-C37D-35A9-FA5690571BF7}"/>
              </a:ext>
            </a:extLst>
          </p:cNvPr>
          <p:cNvSpPr/>
          <p:nvPr/>
        </p:nvSpPr>
        <p:spPr>
          <a:xfrm>
            <a:off x="3021410" y="1961576"/>
            <a:ext cx="524930" cy="3693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 C</a:t>
            </a:r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91CBC652-BDDA-144E-5F06-672592F3793A}"/>
              </a:ext>
            </a:extLst>
          </p:cNvPr>
          <p:cNvSpPr/>
          <p:nvPr/>
        </p:nvSpPr>
        <p:spPr>
          <a:xfrm rot="5400000">
            <a:off x="2415456" y="1485186"/>
            <a:ext cx="233680" cy="69088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BC3BA76-7995-5EFB-EA40-92BBF97C4A81}"/>
              </a:ext>
            </a:extLst>
          </p:cNvPr>
          <p:cNvSpPr/>
          <p:nvPr/>
        </p:nvSpPr>
        <p:spPr>
          <a:xfrm>
            <a:off x="2315839" y="1310221"/>
            <a:ext cx="524930" cy="3693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 E1</a:t>
            </a:r>
          </a:p>
        </p:txBody>
      </p:sp>
      <p:sp>
        <p:nvSpPr>
          <p:cNvPr id="16" name="Left Bracket 15">
            <a:extLst>
              <a:ext uri="{FF2B5EF4-FFF2-40B4-BE49-F238E27FC236}">
                <a16:creationId xmlns:a16="http://schemas.microsoft.com/office/drawing/2014/main" id="{B5F45DCD-0902-A795-0CDA-090B61388A8C}"/>
              </a:ext>
            </a:extLst>
          </p:cNvPr>
          <p:cNvSpPr/>
          <p:nvPr/>
        </p:nvSpPr>
        <p:spPr>
          <a:xfrm rot="5400000">
            <a:off x="3507244" y="1475330"/>
            <a:ext cx="233680" cy="69088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E8EC853-BEB4-F51E-FFA3-0F741F1E161A}"/>
              </a:ext>
            </a:extLst>
          </p:cNvPr>
          <p:cNvSpPr/>
          <p:nvPr/>
        </p:nvSpPr>
        <p:spPr>
          <a:xfrm>
            <a:off x="3407627" y="1300365"/>
            <a:ext cx="524930" cy="3693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 E2</a:t>
            </a:r>
          </a:p>
        </p:txBody>
      </p:sp>
    </p:spTree>
    <p:extLst>
      <p:ext uri="{BB962C8B-B14F-4D97-AF65-F5344CB8AC3E}">
        <p14:creationId xmlns:p14="http://schemas.microsoft.com/office/powerpoint/2010/main" val="18207017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DF32108-275E-B0EA-F74D-DAEAF5FED87B}"/>
              </a:ext>
            </a:extLst>
          </p:cNvPr>
          <p:cNvSpPr txBox="1"/>
          <p:nvPr/>
        </p:nvSpPr>
        <p:spPr>
          <a:xfrm>
            <a:off x="747574" y="5070761"/>
            <a:ext cx="10336985" cy="11309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Representative flow cytometry histograms of CD69 expression on 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 cells (stimulated with 10 µg/ml anti-human CD3 and 1µg/ml anti-human CD28 and simultaneously incubated with 1 µg/ml of purified sCD72 or control for 48 hours at 37°C). </a:t>
            </a: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pPr marL="228600" indent="-228600" algn="just" rtl="0">
              <a:lnSpc>
                <a:spcPct val="150000"/>
              </a:lnSpc>
              <a:spcAft>
                <a:spcPts val="800"/>
              </a:spcAft>
              <a:buAutoNum type="alphaLcParenBoth"/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Isotype control staining pattern, (b) control treatment (c) sCD72 treatment (d) overlay of a-c histograms. </a:t>
            </a:r>
            <a:endParaRPr lang="en-US" sz="1400" dirty="0">
              <a:solidFill>
                <a:srgbClr val="000000"/>
              </a:solidFill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AE1DD817-75FC-65E4-4E6D-88B65B2E1C58}"/>
              </a:ext>
            </a:extLst>
          </p:cNvPr>
          <p:cNvGrpSpPr/>
          <p:nvPr/>
        </p:nvGrpSpPr>
        <p:grpSpPr>
          <a:xfrm>
            <a:off x="2662348" y="90602"/>
            <a:ext cx="6867303" cy="4543425"/>
            <a:chOff x="1226186" y="-113935"/>
            <a:chExt cx="7772400" cy="513754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4C01BC9-6A1C-AC5F-FA37-5B7C485AFD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26186" y="310563"/>
              <a:ext cx="7772400" cy="4713051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0B22983-A2E4-3BC7-06D6-7E9B109B34AB}"/>
                </a:ext>
              </a:extLst>
            </p:cNvPr>
            <p:cNvSpPr txBox="1"/>
            <p:nvPr/>
          </p:nvSpPr>
          <p:spPr>
            <a:xfrm>
              <a:off x="1702790" y="-51568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01BA2CC-33D5-A958-33CA-150FD9CA7F71}"/>
                </a:ext>
              </a:extLst>
            </p:cNvPr>
            <p:cNvSpPr txBox="1"/>
            <p:nvPr/>
          </p:nvSpPr>
          <p:spPr>
            <a:xfrm>
              <a:off x="4118925" y="-16157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4860937-DC3E-811E-DDF9-2EE9E3FD8A24}"/>
                </a:ext>
              </a:extLst>
            </p:cNvPr>
            <p:cNvSpPr txBox="1"/>
            <p:nvPr/>
          </p:nvSpPr>
          <p:spPr>
            <a:xfrm>
              <a:off x="6675161" y="-113935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B718363-F9A2-00EB-06C6-B693299FE299}"/>
                </a:ext>
              </a:extLst>
            </p:cNvPr>
            <p:cNvSpPr txBox="1"/>
            <p:nvPr/>
          </p:nvSpPr>
          <p:spPr>
            <a:xfrm>
              <a:off x="3512881" y="2438214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903D7E7F-4584-8CA9-A26D-875A5E2070A1}"/>
              </a:ext>
            </a:extLst>
          </p:cNvPr>
          <p:cNvSpPr txBox="1"/>
          <p:nvPr/>
        </p:nvSpPr>
        <p:spPr>
          <a:xfrm>
            <a:off x="252896" y="45974"/>
            <a:ext cx="1226811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3A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73613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AB97B8B-BF70-4071-E727-65D570691F95}"/>
              </a:ext>
            </a:extLst>
          </p:cNvPr>
          <p:cNvSpPr txBox="1"/>
          <p:nvPr/>
        </p:nvSpPr>
        <p:spPr>
          <a:xfrm>
            <a:off x="415811" y="21582"/>
            <a:ext cx="1226811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3B: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B1CF188-E544-DC25-025E-03B4BA97E5CA}"/>
              </a:ext>
            </a:extLst>
          </p:cNvPr>
          <p:cNvSpPr txBox="1"/>
          <p:nvPr/>
        </p:nvSpPr>
        <p:spPr>
          <a:xfrm>
            <a:off x="415811" y="5315529"/>
            <a:ext cx="10551095" cy="11309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Representative flow cytometry histograms of IL-17A expression in 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 cells (stimulated with 10 µg/ml anti-human CD3 and 1µg/ml anti-human CD28 and simultaneously incubated with 1 µg/ml of purified sCD72 or control for 48 hours at 37°C). </a:t>
            </a: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pPr marL="228600" indent="-228600" algn="just" rtl="0">
              <a:lnSpc>
                <a:spcPct val="150000"/>
              </a:lnSpc>
              <a:spcAft>
                <a:spcPts val="800"/>
              </a:spcAft>
              <a:buAutoNum type="alphaLcParenBoth"/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Isotype control staining pattern, (b) control treatment (c) sCD72 treatment (d) overlay of a-c histograms. </a:t>
            </a:r>
            <a:endParaRPr lang="en-US" sz="1400" dirty="0">
              <a:solidFill>
                <a:srgbClr val="000000"/>
              </a:solidFill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7C409E0-3CAD-5B25-FF07-A14F79BE2D6A}"/>
              </a:ext>
            </a:extLst>
          </p:cNvPr>
          <p:cNvGrpSpPr/>
          <p:nvPr/>
        </p:nvGrpSpPr>
        <p:grpSpPr>
          <a:xfrm>
            <a:off x="3194506" y="255782"/>
            <a:ext cx="7772400" cy="5059747"/>
            <a:chOff x="3119869" y="313781"/>
            <a:chExt cx="7772400" cy="505974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096398B-B190-003D-2DCB-8F6FCF7C88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19869" y="679882"/>
              <a:ext cx="7772400" cy="469364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38B02BE-EFC1-06DC-12F5-E499AE3C8346}"/>
                </a:ext>
              </a:extLst>
            </p:cNvPr>
            <p:cNvSpPr txBox="1"/>
            <p:nvPr/>
          </p:nvSpPr>
          <p:spPr>
            <a:xfrm>
              <a:off x="3500011" y="368936"/>
              <a:ext cx="272220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D6AB28C-10A6-3831-8604-035ACB8A04F6}"/>
                </a:ext>
              </a:extLst>
            </p:cNvPr>
            <p:cNvSpPr txBox="1"/>
            <p:nvPr/>
          </p:nvSpPr>
          <p:spPr>
            <a:xfrm>
              <a:off x="5766867" y="390092"/>
              <a:ext cx="277885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81CA573-07B7-4978-ABB7-2DFE6F021EF2}"/>
                </a:ext>
              </a:extLst>
            </p:cNvPr>
            <p:cNvSpPr txBox="1"/>
            <p:nvPr/>
          </p:nvSpPr>
          <p:spPr>
            <a:xfrm>
              <a:off x="8228629" y="313781"/>
              <a:ext cx="270803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F064F6B-89E5-7077-4C92-3D9308B95C40}"/>
                </a:ext>
              </a:extLst>
            </p:cNvPr>
            <p:cNvSpPr txBox="1"/>
            <p:nvPr/>
          </p:nvSpPr>
          <p:spPr>
            <a:xfrm>
              <a:off x="5150117" y="2834951"/>
              <a:ext cx="277885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737107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BA8B903-4F87-318F-B6EE-0EF551263003}"/>
              </a:ext>
            </a:extLst>
          </p:cNvPr>
          <p:cNvSpPr txBox="1"/>
          <p:nvPr/>
        </p:nvSpPr>
        <p:spPr>
          <a:xfrm>
            <a:off x="171971" y="89598"/>
            <a:ext cx="1228413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3C: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61F37D-DA03-DDCC-28BD-A362C3F6FABB}"/>
              </a:ext>
            </a:extLst>
          </p:cNvPr>
          <p:cNvSpPr txBox="1"/>
          <p:nvPr/>
        </p:nvSpPr>
        <p:spPr>
          <a:xfrm>
            <a:off x="434747" y="5392977"/>
            <a:ext cx="11322505" cy="11309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Representative flow cytometry histograms of IFN-gamma expression in 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 cells (stimulated with 10 µg/ml anti-human CD3 and 1µg/ml anti-human CD28 and simultaneously incubated with 1 µg/ml of purified sCD72 or control for 48 hours at 37°C). </a:t>
            </a: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(a)Isotype control staining pattern, (b) control treatment (c) sCD72 treatment (d) overlay of a-c histograms. </a:t>
            </a:r>
            <a:endParaRPr lang="en-US" sz="1400" dirty="0">
              <a:solidFill>
                <a:srgbClr val="000000"/>
              </a:solidFill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C5F1CAFB-D87F-9615-81C8-0ACAE4D7A076}"/>
              </a:ext>
            </a:extLst>
          </p:cNvPr>
          <p:cNvGrpSpPr/>
          <p:nvPr/>
        </p:nvGrpSpPr>
        <p:grpSpPr>
          <a:xfrm>
            <a:off x="2981960" y="110954"/>
            <a:ext cx="7772400" cy="5282023"/>
            <a:chOff x="3083560" y="202394"/>
            <a:chExt cx="7772400" cy="528202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9E31021-783E-8DAD-5E6F-D1CA2AE1C9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83560" y="679882"/>
              <a:ext cx="7772400" cy="480453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03E3CEF-BA9C-5EEA-81DC-A2AD7F6B5A67}"/>
                </a:ext>
              </a:extLst>
            </p:cNvPr>
            <p:cNvSpPr txBox="1"/>
            <p:nvPr/>
          </p:nvSpPr>
          <p:spPr>
            <a:xfrm>
              <a:off x="3703211" y="202394"/>
              <a:ext cx="272220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EF06520-D3EF-6100-676F-26247D86A754}"/>
                </a:ext>
              </a:extLst>
            </p:cNvPr>
            <p:cNvSpPr txBox="1"/>
            <p:nvPr/>
          </p:nvSpPr>
          <p:spPr>
            <a:xfrm>
              <a:off x="6041187" y="233710"/>
              <a:ext cx="277885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AD99F7E-D0A8-32AB-9817-ED646EE70385}"/>
                </a:ext>
              </a:extLst>
            </p:cNvPr>
            <p:cNvSpPr txBox="1"/>
            <p:nvPr/>
          </p:nvSpPr>
          <p:spPr>
            <a:xfrm>
              <a:off x="8739457" y="233710"/>
              <a:ext cx="270803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E91FC7F-E3BC-5060-1D6B-AC5DB1CFE14D}"/>
                </a:ext>
              </a:extLst>
            </p:cNvPr>
            <p:cNvSpPr txBox="1"/>
            <p:nvPr/>
          </p:nvSpPr>
          <p:spPr>
            <a:xfrm>
              <a:off x="5272037" y="2835292"/>
              <a:ext cx="277885" cy="3266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244603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2729" y="91355"/>
            <a:ext cx="1247649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3D:</a:t>
            </a:r>
            <a:endParaRPr lang="en-US" dirty="0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3661087"/>
              </p:ext>
            </p:extLst>
          </p:nvPr>
        </p:nvGraphicFramePr>
        <p:xfrm>
          <a:off x="746135" y="813264"/>
          <a:ext cx="4552591" cy="2615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917163"/>
              </p:ext>
            </p:extLst>
          </p:nvPr>
        </p:nvGraphicFramePr>
        <p:xfrm>
          <a:off x="6187248" y="813264"/>
          <a:ext cx="4787661" cy="2615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4300825"/>
              </p:ext>
            </p:extLst>
          </p:nvPr>
        </p:nvGraphicFramePr>
        <p:xfrm>
          <a:off x="6345399" y="3961907"/>
          <a:ext cx="4741651" cy="109838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62383">
                  <a:extLst>
                    <a:ext uri="{9D8B030D-6E8A-4147-A177-3AD203B41FA5}">
                      <a16:colId xmlns:a16="http://schemas.microsoft.com/office/drawing/2014/main" val="1387961973"/>
                    </a:ext>
                  </a:extLst>
                </a:gridCol>
                <a:gridCol w="743333">
                  <a:extLst>
                    <a:ext uri="{9D8B030D-6E8A-4147-A177-3AD203B41FA5}">
                      <a16:colId xmlns:a16="http://schemas.microsoft.com/office/drawing/2014/main" val="2525597646"/>
                    </a:ext>
                  </a:extLst>
                </a:gridCol>
                <a:gridCol w="627187">
                  <a:extLst>
                    <a:ext uri="{9D8B030D-6E8A-4147-A177-3AD203B41FA5}">
                      <a16:colId xmlns:a16="http://schemas.microsoft.com/office/drawing/2014/main" val="2049109515"/>
                    </a:ext>
                  </a:extLst>
                </a:gridCol>
                <a:gridCol w="627187">
                  <a:extLst>
                    <a:ext uri="{9D8B030D-6E8A-4147-A177-3AD203B41FA5}">
                      <a16:colId xmlns:a16="http://schemas.microsoft.com/office/drawing/2014/main" val="845309832"/>
                    </a:ext>
                  </a:extLst>
                </a:gridCol>
                <a:gridCol w="627187">
                  <a:extLst>
                    <a:ext uri="{9D8B030D-6E8A-4147-A177-3AD203B41FA5}">
                      <a16:colId xmlns:a16="http://schemas.microsoft.com/office/drawing/2014/main" val="703322409"/>
                    </a:ext>
                  </a:extLst>
                </a:gridCol>
                <a:gridCol w="627187">
                  <a:extLst>
                    <a:ext uri="{9D8B030D-6E8A-4147-A177-3AD203B41FA5}">
                      <a16:colId xmlns:a16="http://schemas.microsoft.com/office/drawing/2014/main" val="3896078708"/>
                    </a:ext>
                  </a:extLst>
                </a:gridCol>
                <a:gridCol w="627187">
                  <a:extLst>
                    <a:ext uri="{9D8B030D-6E8A-4147-A177-3AD203B41FA5}">
                      <a16:colId xmlns:a16="http://schemas.microsoft.com/office/drawing/2014/main" val="4157503145"/>
                    </a:ext>
                  </a:extLst>
                </a:gridCol>
              </a:tblGrid>
              <a:tr h="1439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ample Nam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vent #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F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V %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nal 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n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10539740"/>
                  </a:ext>
                </a:extLst>
              </a:tr>
              <a:tr h="4696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ntrol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548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32012.64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5975.43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24.84%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1450.31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g/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95815350"/>
                  </a:ext>
                </a:extLst>
              </a:tr>
              <a:tr h="4848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CD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490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67590.60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12093.72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22.24%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3700.74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pg</a:t>
                      </a:r>
                      <a:r>
                        <a:rPr lang="en-US" sz="800" u="none" strike="noStrike" dirty="0">
                          <a:effectLst/>
                        </a:rPr>
                        <a:t>/m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49899038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6406777"/>
              </p:ext>
            </p:extLst>
          </p:nvPr>
        </p:nvGraphicFramePr>
        <p:xfrm>
          <a:off x="614283" y="3961907"/>
          <a:ext cx="4816297" cy="118851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06730">
                  <a:extLst>
                    <a:ext uri="{9D8B030D-6E8A-4147-A177-3AD203B41FA5}">
                      <a16:colId xmlns:a16="http://schemas.microsoft.com/office/drawing/2014/main" val="166850830"/>
                    </a:ext>
                  </a:extLst>
                </a:gridCol>
                <a:gridCol w="758567">
                  <a:extLst>
                    <a:ext uri="{9D8B030D-6E8A-4147-A177-3AD203B41FA5}">
                      <a16:colId xmlns:a16="http://schemas.microsoft.com/office/drawing/2014/main" val="1876272160"/>
                    </a:ext>
                  </a:extLst>
                </a:gridCol>
                <a:gridCol w="650200">
                  <a:extLst>
                    <a:ext uri="{9D8B030D-6E8A-4147-A177-3AD203B41FA5}">
                      <a16:colId xmlns:a16="http://schemas.microsoft.com/office/drawing/2014/main" val="2934029741"/>
                    </a:ext>
                  </a:extLst>
                </a:gridCol>
                <a:gridCol w="650200">
                  <a:extLst>
                    <a:ext uri="{9D8B030D-6E8A-4147-A177-3AD203B41FA5}">
                      <a16:colId xmlns:a16="http://schemas.microsoft.com/office/drawing/2014/main" val="914278890"/>
                    </a:ext>
                  </a:extLst>
                </a:gridCol>
                <a:gridCol w="650200">
                  <a:extLst>
                    <a:ext uri="{9D8B030D-6E8A-4147-A177-3AD203B41FA5}">
                      <a16:colId xmlns:a16="http://schemas.microsoft.com/office/drawing/2014/main" val="2188212508"/>
                    </a:ext>
                  </a:extLst>
                </a:gridCol>
                <a:gridCol w="650200">
                  <a:extLst>
                    <a:ext uri="{9D8B030D-6E8A-4147-A177-3AD203B41FA5}">
                      <a16:colId xmlns:a16="http://schemas.microsoft.com/office/drawing/2014/main" val="2178201678"/>
                    </a:ext>
                  </a:extLst>
                </a:gridCol>
                <a:gridCol w="650200">
                  <a:extLst>
                    <a:ext uri="{9D8B030D-6E8A-4147-A177-3AD203B41FA5}">
                      <a16:colId xmlns:a16="http://schemas.microsoft.com/office/drawing/2014/main" val="3949690143"/>
                    </a:ext>
                  </a:extLst>
                </a:gridCol>
              </a:tblGrid>
              <a:tr h="1438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ample Nam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vent #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F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V %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nal 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n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05362475"/>
                  </a:ext>
                </a:extLst>
              </a:tr>
              <a:tr h="46934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ntro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475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2564.10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565.58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24.66%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200.31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g/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92743817"/>
                  </a:ext>
                </a:extLst>
              </a:tr>
              <a:tr h="5753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  sCD7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479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30089.40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5792.32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23.93%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800" u="none" strike="noStrike">
                          <a:effectLst/>
                        </a:rPr>
                        <a:t>1782.08</a:t>
                      </a:r>
                      <a:endParaRPr lang="he-IL" sz="800" b="0" i="0" u="none" strike="noStrike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pg</a:t>
                      </a:r>
                      <a:r>
                        <a:rPr lang="en-US" sz="800" u="none" strike="noStrike" dirty="0">
                          <a:effectLst/>
                        </a:rPr>
                        <a:t>/m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ahoma" panose="020B060403050404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11124564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5D07DE5A-EACB-1913-16D1-9A13E0922B69}"/>
              </a:ext>
            </a:extLst>
          </p:cNvPr>
          <p:cNvSpPr txBox="1"/>
          <p:nvPr/>
        </p:nvSpPr>
        <p:spPr>
          <a:xfrm>
            <a:off x="1046480" y="5588236"/>
            <a:ext cx="9337040" cy="10283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dirty="0"/>
              <a:t>BD® Cytometric Bead Array results for (a) IL-17A and (b) IFN-gamma secretion in the conditioned media of CD4+T cells stimulated with 10 µg/ml anti-human CD3 and 1µg/ml anti-human CD28 and simultaneously incubated with 1 µg/ml of purified sCD72 or control for 48 hours at 37°C.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D42CAF4-F472-09D3-9F60-A253EDB8C3C8}"/>
              </a:ext>
            </a:extLst>
          </p:cNvPr>
          <p:cNvSpPr txBox="1"/>
          <p:nvPr/>
        </p:nvSpPr>
        <p:spPr>
          <a:xfrm>
            <a:off x="944871" y="727140"/>
            <a:ext cx="272220" cy="326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D74614E-568E-7863-AD1D-25DE1BDCF4E3}"/>
              </a:ext>
            </a:extLst>
          </p:cNvPr>
          <p:cNvSpPr txBox="1"/>
          <p:nvPr/>
        </p:nvSpPr>
        <p:spPr>
          <a:xfrm>
            <a:off x="6610147" y="721390"/>
            <a:ext cx="272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875588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55BDD89-C32B-93BD-616A-0AEDB01136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8916646"/>
              </p:ext>
            </p:extLst>
          </p:nvPr>
        </p:nvGraphicFramePr>
        <p:xfrm>
          <a:off x="2403429" y="679882"/>
          <a:ext cx="5883058" cy="4632960"/>
        </p:xfrm>
        <a:graphic>
          <a:graphicData uri="http://schemas.openxmlformats.org/drawingml/2006/table">
            <a:tbl>
              <a:tblPr firstRow="1" bandRow="1"/>
              <a:tblGrid>
                <a:gridCol w="1456137">
                  <a:extLst>
                    <a:ext uri="{9D8B030D-6E8A-4147-A177-3AD203B41FA5}">
                      <a16:colId xmlns:a16="http://schemas.microsoft.com/office/drawing/2014/main" val="320081223"/>
                    </a:ext>
                  </a:extLst>
                </a:gridCol>
                <a:gridCol w="1547264">
                  <a:extLst>
                    <a:ext uri="{9D8B030D-6E8A-4147-A177-3AD203B41FA5}">
                      <a16:colId xmlns:a16="http://schemas.microsoft.com/office/drawing/2014/main" val="1108412307"/>
                    </a:ext>
                  </a:extLst>
                </a:gridCol>
                <a:gridCol w="1547264">
                  <a:extLst>
                    <a:ext uri="{9D8B030D-6E8A-4147-A177-3AD203B41FA5}">
                      <a16:colId xmlns:a16="http://schemas.microsoft.com/office/drawing/2014/main" val="1122024924"/>
                    </a:ext>
                  </a:extLst>
                </a:gridCol>
                <a:gridCol w="1332393">
                  <a:extLst>
                    <a:ext uri="{9D8B030D-6E8A-4147-A177-3AD203B41FA5}">
                      <a16:colId xmlns:a16="http://schemas.microsoft.com/office/drawing/2014/main" val="3295770284"/>
                    </a:ext>
                  </a:extLst>
                </a:gridCol>
              </a:tblGrid>
              <a:tr h="4499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 (%)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D72 (%)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7049104"/>
                  </a:ext>
                </a:extLst>
              </a:tr>
              <a:tr h="51407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69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.72±5.28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.66±14.56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475175"/>
                  </a:ext>
                </a:extLst>
              </a:tr>
              <a:tr h="51407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17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06±5.27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.91±13.57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0854293"/>
                  </a:ext>
                </a:extLst>
              </a:tr>
              <a:tr h="51407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-γ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14±4.06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.34±3.17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7464267"/>
                  </a:ext>
                </a:extLst>
              </a:tr>
              <a:tr h="51407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0L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.10±15.97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.10±34.18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3638080"/>
                  </a:ext>
                </a:extLst>
              </a:tr>
              <a:tr h="51407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25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.56±23.1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.25±18.9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6601063"/>
                  </a:ext>
                </a:extLst>
              </a:tr>
              <a:tr h="51407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LA-4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.6±3.74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56±10.57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6665988"/>
                  </a:ext>
                </a:extLst>
              </a:tr>
              <a:tr h="51407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10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.7±23.0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.1±17.2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4100218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82131" y="204668"/>
            <a:ext cx="1017843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Table S1: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B25B177-02E8-9C66-3686-E96C16902D6B}"/>
              </a:ext>
            </a:extLst>
          </p:cNvPr>
          <p:cNvSpPr txBox="1"/>
          <p:nvPr/>
        </p:nvSpPr>
        <p:spPr>
          <a:xfrm>
            <a:off x="434747" y="5226146"/>
            <a:ext cx="11322505" cy="11309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Purified human CD4+T cells were stimulated with 10 µg/ml anti-human CD3 and 1µg/ml anti-human CD28 and simultaneously incubated with 1 µg/ml of purified sCD72 or control for 48 hours at 37°C. </a:t>
            </a:r>
          </a:p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The table above shows the flow cytometry results of </a:t>
            </a:r>
            <a:r>
              <a:rPr lang="en-US" sz="1400" dirty="0" err="1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mean</a:t>
            </a:r>
            <a:r>
              <a:rPr lang="en-US" sz="14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±SD</a:t>
            </a:r>
            <a:r>
              <a:rPr lang="en-US" sz="1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expression levels in T cells </a:t>
            </a: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stimulated with sCD72 compared to the control. </a:t>
            </a:r>
          </a:p>
        </p:txBody>
      </p:sp>
    </p:spTree>
    <p:extLst>
      <p:ext uri="{BB962C8B-B14F-4D97-AF65-F5344CB8AC3E}">
        <p14:creationId xmlns:p14="http://schemas.microsoft.com/office/powerpoint/2010/main" val="25392438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2109" y="75836"/>
            <a:ext cx="1104982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Figure S4: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0050013"/>
              </p:ext>
            </p:extLst>
          </p:nvPr>
        </p:nvGraphicFramePr>
        <p:xfrm>
          <a:off x="516927" y="1067604"/>
          <a:ext cx="3286429" cy="25824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Project" r:id="rId3" imgW="4536000" imgH="3564000" progId="Prism5.Document">
                  <p:embed/>
                </p:oleObj>
              </mc:Choice>
              <mc:Fallback>
                <p:oleObj name="Prism Project" r:id="rId3" imgW="4536000" imgH="356400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6927" y="1067604"/>
                        <a:ext cx="3286429" cy="25824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5337719"/>
              </p:ext>
            </p:extLst>
          </p:nvPr>
        </p:nvGraphicFramePr>
        <p:xfrm>
          <a:off x="3149028" y="1218302"/>
          <a:ext cx="3071660" cy="24136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Project" r:id="rId5" imgW="4536000" imgH="3564000" progId="Prism5.Document">
                  <p:embed/>
                </p:oleObj>
              </mc:Choice>
              <mc:Fallback>
                <p:oleObj name="Prism Project" r:id="rId5" imgW="4536000" imgH="356400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49028" y="1218302"/>
                        <a:ext cx="3071660" cy="24136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3770989"/>
              </p:ext>
            </p:extLst>
          </p:nvPr>
        </p:nvGraphicFramePr>
        <p:xfrm>
          <a:off x="5951569" y="1184231"/>
          <a:ext cx="3138008" cy="2465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Prism Project" r:id="rId7" imgW="4536000" imgH="3564000" progId="Prism5.Document">
                  <p:embed/>
                </p:oleObj>
              </mc:Choice>
              <mc:Fallback>
                <p:oleObj name="Prism Project" r:id="rId7" imgW="4536000" imgH="356400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51569" y="1184231"/>
                        <a:ext cx="3138008" cy="2465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2805326"/>
              </p:ext>
            </p:extLst>
          </p:nvPr>
        </p:nvGraphicFramePr>
        <p:xfrm>
          <a:off x="8693901" y="1254427"/>
          <a:ext cx="3025688" cy="23775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Prism Project" r:id="rId9" imgW="4536000" imgH="3564000" progId="Prism5.Document">
                  <p:embed/>
                </p:oleObj>
              </mc:Choice>
              <mc:Fallback>
                <p:oleObj name="Prism Project" r:id="rId9" imgW="4536000" imgH="356400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693901" y="1254427"/>
                        <a:ext cx="3025688" cy="23775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E37C5DF-0935-38CE-2F99-567A68A48B1A}"/>
              </a:ext>
            </a:extLst>
          </p:cNvPr>
          <p:cNvSpPr txBox="1"/>
          <p:nvPr/>
        </p:nvSpPr>
        <p:spPr>
          <a:xfrm>
            <a:off x="290316" y="4762038"/>
            <a:ext cx="11322505" cy="10283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Purified human CD4+T cells were stimulated with 10 µg/ml anti-human CD3 and 1µg/ml anti-human CD28 and simultaneously incubated with 1 µg/ml of purified sCD72 or control for 48 hours at 37°C. The flow cytometry results of (a) CD40L expression, (b) CD25 expression, (c) CTLA-4 expression , and (d) IL-10 levels due to sCD72 stimulation compared to control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EDDFE22-1AB9-4C94-C7D1-F7DE16E49E42}"/>
              </a:ext>
            </a:extLst>
          </p:cNvPr>
          <p:cNvSpPr txBox="1"/>
          <p:nvPr/>
        </p:nvSpPr>
        <p:spPr>
          <a:xfrm>
            <a:off x="944871" y="727140"/>
            <a:ext cx="272220" cy="326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B90CC27-DB6D-DE52-E307-8D00A245219A}"/>
              </a:ext>
            </a:extLst>
          </p:cNvPr>
          <p:cNvSpPr txBox="1"/>
          <p:nvPr/>
        </p:nvSpPr>
        <p:spPr>
          <a:xfrm>
            <a:off x="3352791" y="788100"/>
            <a:ext cx="272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57970E-E985-8675-6B2E-FBC2E3BA7D6C}"/>
              </a:ext>
            </a:extLst>
          </p:cNvPr>
          <p:cNvSpPr txBox="1"/>
          <p:nvPr/>
        </p:nvSpPr>
        <p:spPr>
          <a:xfrm>
            <a:off x="6339831" y="87954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BA3D1E-BABB-EF7D-3F47-B67F84E0E387}"/>
              </a:ext>
            </a:extLst>
          </p:cNvPr>
          <p:cNvSpPr txBox="1"/>
          <p:nvPr/>
        </p:nvSpPr>
        <p:spPr>
          <a:xfrm>
            <a:off x="9052551" y="87954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588941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94</TotalTime>
  <Words>744</Words>
  <Application>Microsoft Office PowerPoint</Application>
  <PresentationFormat>מסך רחב</PresentationFormat>
  <Paragraphs>139</Paragraphs>
  <Slides>9</Slides>
  <Notes>0</Notes>
  <HiddenSlides>0</HiddenSlides>
  <MMClips>0</MMClips>
  <ScaleCrop>false</ScaleCrop>
  <HeadingPairs>
    <vt:vector size="8" baseType="variant">
      <vt:variant>
        <vt:lpstr>גופנים בשימוש</vt:lpstr>
      </vt:variant>
      <vt:variant>
        <vt:i4>6</vt:i4>
      </vt:variant>
      <vt:variant>
        <vt:lpstr>ערכת נושא</vt:lpstr>
      </vt:variant>
      <vt:variant>
        <vt:i4>1</vt:i4>
      </vt:variant>
      <vt:variant>
        <vt:lpstr>שרתי OLE מוטבעים</vt:lpstr>
      </vt:variant>
      <vt:variant>
        <vt:i4>1</vt:i4>
      </vt:variant>
      <vt:variant>
        <vt:lpstr>כותרות שקופיות</vt:lpstr>
      </vt:variant>
      <vt:variant>
        <vt:i4>9</vt:i4>
      </vt:variant>
    </vt:vector>
  </HeadingPairs>
  <TitlesOfParts>
    <vt:vector size="17" baseType="lpstr">
      <vt:lpstr>Arial</vt:lpstr>
      <vt:lpstr>Calibri</vt:lpstr>
      <vt:lpstr>Calibri Light</vt:lpstr>
      <vt:lpstr>Tahoma</vt:lpstr>
      <vt:lpstr>Times New Roman</vt:lpstr>
      <vt:lpstr>Verdana</vt:lpstr>
      <vt:lpstr>Office Theme</vt:lpstr>
      <vt:lpstr>Prism Project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  <vt:lpstr>מצגת של PowerPoint‏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a  Lab users</dc:creator>
  <cp:lastModifiedBy>zahava.vadas</cp:lastModifiedBy>
  <cp:revision>38</cp:revision>
  <dcterms:created xsi:type="dcterms:W3CDTF">2023-12-09T13:27:20Z</dcterms:created>
  <dcterms:modified xsi:type="dcterms:W3CDTF">2024-05-15T08:19:12Z</dcterms:modified>
</cp:coreProperties>
</file>